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20D78-DAB8-4604-8EDE-1D1D85F558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A28361-9928-47D8-90A3-AD020B6166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044EC-D785-406E-9865-A7B8787488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7693E-B169-4E22-9012-6E1582BC7E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39CB9-E751-4836-9333-5C590FD218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9E0DB-26DC-480E-82F0-7B9816AE77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65F07-AA67-4594-AC4F-DEAA2E5136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5AB76-B866-4D97-8C06-DF2E15D012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5BA65-4DB4-4EC8-8A50-6B2CBBD96E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88DF1-2FB9-4FF0-A8E2-AB75A8498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A731F-260A-4C94-B5E0-8BDDB8479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2CD8C-58E2-426F-B3CC-E8F496662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B5EA37-5054-4DFF-BEA1-FA310EE59E7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silkworm.swu.edu.cn/microarray" TargetMode="External"/><Relationship Id="rId3" Type="http://schemas.openxmlformats.org/officeDocument/2006/relationships/hyperlink" Target="http://silkworm.swu.edu.cn/microarray" TargetMode="External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19240" y="549360"/>
            <a:ext cx="8600760" cy="4734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4000" y="5524920"/>
            <a:ext cx="86407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Supplemental Figure 5. A screenshot of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the database for the silkworm microarray data</a:t>
            </a: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0" lang="zh-CN" sz="1600" spc="-1" strike="noStrike" u="sng">
                <a:solidFill>
                  <a:srgbClr val="009999"/>
                </a:solidFill>
                <a:uFillTx/>
                <a:latin typeface="Times New Roman"/>
                <a:hlinkClick r:id="rId2"/>
              </a:rPr>
              <a:t>http</a:t>
            </a:r>
            <a:r>
              <a:rPr b="0" lang="zh-CN" sz="1600" spc="-1" strike="noStrike" u="sng">
                <a:solidFill>
                  <a:srgbClr val="009999"/>
                </a:solidFill>
                <a:uFillTx/>
                <a:latin typeface="Times New Roman"/>
                <a:hlinkClick r:id="rId3"/>
              </a:rPr>
              <a:t>://silkworm.swu.edu.cn/ microarray/BmMDB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). All raw data and tissue-specific genes were viewed in this database. Genes illustrated in colored columns were midgut-specific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7:20:01Z</dcterms:created>
  <dc:creator>番茄花园</dc:creator>
  <dc:description/>
  <dc:language>en-US</dc:language>
  <cp:lastModifiedBy>chengdj</cp:lastModifiedBy>
  <dcterms:modified xsi:type="dcterms:W3CDTF">2007-06-12T19:15:07Z</dcterms:modified>
  <cp:revision>5</cp:revision>
  <dc:subject/>
  <dc:title>幻灯片 1</dc:title>
</cp:coreProperties>
</file>